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718"/>
    <p:restoredTop sz="94628"/>
  </p:normalViewPr>
  <p:slideViewPr>
    <p:cSldViewPr snapToGrid="0">
      <p:cViewPr varScale="1">
        <p:scale>
          <a:sx n="79" d="100"/>
          <a:sy n="79" d="100"/>
        </p:scale>
        <p:origin x="1264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6440D-B225-FA49-93B1-7E0586C88DCF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BB839-48EA-8C4B-A147-00B7E304361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01303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6440D-B225-FA49-93B1-7E0586C88DCF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BB839-48EA-8C4B-A147-00B7E304361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159937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6440D-B225-FA49-93B1-7E0586C88DCF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BB839-48EA-8C4B-A147-00B7E304361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5370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6440D-B225-FA49-93B1-7E0586C88DCF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BB839-48EA-8C4B-A147-00B7E304361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73491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6440D-B225-FA49-93B1-7E0586C88DCF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BB839-48EA-8C4B-A147-00B7E304361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34962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6440D-B225-FA49-93B1-7E0586C88DCF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BB839-48EA-8C4B-A147-00B7E304361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59669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6440D-B225-FA49-93B1-7E0586C88DCF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BB839-48EA-8C4B-A147-00B7E304361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88823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6440D-B225-FA49-93B1-7E0586C88DCF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BB839-48EA-8C4B-A147-00B7E304361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86462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6440D-B225-FA49-93B1-7E0586C88DCF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BB839-48EA-8C4B-A147-00B7E304361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62169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6440D-B225-FA49-93B1-7E0586C88DCF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BB839-48EA-8C4B-A147-00B7E304361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59226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36440D-B225-FA49-93B1-7E0586C88DCF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BB839-48EA-8C4B-A147-00B7E304361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60452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36440D-B225-FA49-93B1-7E0586C88DCF}" type="datetimeFigureOut">
              <a:rPr kumimoji="1" lang="zh-CN" altLang="en-US" smtClean="0"/>
              <a:t>2022/9/2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BB839-48EA-8C4B-A147-00B7E304361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02124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F8913E7-E4E5-EBA2-BB0E-9E4B988C00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73629"/>
            <a:ext cx="6858000" cy="36520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75752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75BC3A5C-9046-C2E3-8F94-AA125958291E}"/>
              </a:ext>
            </a:extLst>
          </p:cNvPr>
          <p:cNvSpPr txBox="1"/>
          <p:nvPr/>
        </p:nvSpPr>
        <p:spPr>
          <a:xfrm>
            <a:off x="171450" y="6201234"/>
            <a:ext cx="6515100" cy="20020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. S1 Cold tolerance performance of the homo- and hetero-grafted plants of </a:t>
            </a:r>
            <a:r>
              <a:rPr lang="en-US" altLang="zh-CN" sz="1200" b="1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200" b="1" i="1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ycopersicum</a:t>
            </a:r>
            <a:r>
              <a:rPr lang="en-US" altLang="zh-CN" sz="1200" b="1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zh-CN" sz="1200" b="1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200" b="1" i="1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abrochaites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endParaRPr lang="zh-CN" altLang="zh-CN" sz="12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Phenotype of the grafted seedlings under cold treatment at 4</a:t>
            </a:r>
            <a:r>
              <a:rPr lang="zh-CN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°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Relative electrolyte leakage (REL)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MDA content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Relative water content (RWC). Data are the means of three biological replicates (±SDs) with three technical replicates each. Data were subjected to one-way analysis of variance (ANOVA), followed by Duncan's Multiple Range Test. Bars marked with different letters differ significantly at P &lt; 0.05.</a:t>
            </a:r>
            <a:endParaRPr lang="zh-CN" altLang="zh-CN" sz="12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50879FE6-D83B-A708-942E-6735C154FD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24508"/>
            <a:ext cx="6858000" cy="57993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43194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85A0ED6C-89E1-F157-5321-0EC7799E2333}"/>
              </a:ext>
            </a:extLst>
          </p:cNvPr>
          <p:cNvSpPr txBox="1"/>
          <p:nvPr/>
        </p:nvSpPr>
        <p:spPr>
          <a:xfrm>
            <a:off x="0" y="7121904"/>
            <a:ext cx="6858000" cy="28330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. S2. Difference of cold-responsive genes (CRGs) between tolerant and sensitive scions under cold stress.</a:t>
            </a:r>
            <a:endParaRPr lang="zh-CN" altLang="zh-CN" sz="12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-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GO enrichment based on cold-responsive up-regulated (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and down-regulated (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genes exclusively identified both in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oha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nd Hetero scions.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olour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panels illustrate the significant level of enrichment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Venn diagram of DEGs in scions in the comparison between 655 MTJA genes and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olyc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DEGs, 655 MTJA genes and Hetero DEGs, 655 MTJA genes and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oha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DEGs.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ycopersicum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homo-grafting (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olyc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,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ycopersicum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eedlings grafted onto rootstock of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abrochaites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(Hetero), and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abrochaites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homo-grafting (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ohab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were treated with cold at 4 °C.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MTJA stands for MYC2-targeted JA-responsive, and DEGs stands for cold-responsive genes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The Number of overlapping in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olyc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Hetero,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oha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CRGs and MTJA genes in scion.</a:t>
            </a:r>
            <a:endParaRPr lang="zh-CN" altLang="zh-CN" sz="12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3D308C7-4616-316D-56F5-E28056401C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0186" y="128815"/>
            <a:ext cx="4954814" cy="71179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04673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81871C5D-74E5-983A-2994-CB1FB666E0C9}"/>
              </a:ext>
            </a:extLst>
          </p:cNvPr>
          <p:cNvSpPr txBox="1"/>
          <p:nvPr/>
        </p:nvSpPr>
        <p:spPr>
          <a:xfrm>
            <a:off x="408214" y="2463799"/>
            <a:ext cx="6041571" cy="17250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. S3. Gene expression of </a:t>
            </a:r>
            <a:r>
              <a:rPr lang="en-US" altLang="zh-CN" sz="1200" b="1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200" b="1" i="1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abrochaites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LA1777 and </a:t>
            </a:r>
            <a:r>
              <a:rPr lang="en-US" altLang="zh-CN" sz="1200" b="1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200" b="1" i="1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ycopersicum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LA4024 was analyzed by using RT-qPCR.</a:t>
            </a:r>
            <a:endParaRPr lang="zh-CN" altLang="zh-CN" sz="12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Expression analysis of related genes (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OD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;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POD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;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AT;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MYC2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) by RT-qPCR in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200" i="1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abrochaites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LA1777 and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200" i="1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ycopersicum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A4024 under cold stress. Statistical significance levels (Student’s t-test) are shown: ns, no significant; *, P ≤ 0.05; **, P ≤ 0.01; ***, P ≤ 0.001; ****, P ≤ 0.0001.</a:t>
            </a:r>
            <a:endParaRPr lang="zh-CN" altLang="zh-CN" sz="12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394A82DC-ADD9-DF55-5D8C-F611ECFED2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800" y="609599"/>
            <a:ext cx="6553200" cy="1854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12926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FFF2E216-F611-2C71-4FB6-67C61AB6B104}"/>
              </a:ext>
            </a:extLst>
          </p:cNvPr>
          <p:cNvSpPr txBox="1"/>
          <p:nvPr/>
        </p:nvSpPr>
        <p:spPr>
          <a:xfrm>
            <a:off x="314325" y="2319703"/>
            <a:ext cx="6229350" cy="17250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. S4 Exogenous JA promotes cold tolerance of </a:t>
            </a:r>
            <a:r>
              <a:rPr lang="en-US" altLang="zh-CN" sz="1200" b="1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olyc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2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Relative water content (RWC)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MDA content. Data are the means of three biological replicates (±SDs) with three technical replicates each. At the five-leaf stage,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200" i="1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lycopersicum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homo-grafts (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olyc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were treated with deionized water, 200 </a:t>
            </a:r>
            <a:r>
              <a:rPr lang="el-GR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M JA or 200 </a:t>
            </a:r>
            <a:r>
              <a:rPr lang="el-GR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M DIECA for 12 h before they were subjected to cold stress at 4°C. Statistical significance levels (Student’s t-test) are shown: ns, no significant; *, P ≤ 0.05; **, P ≤ 0.01; ***, P ≤ 0.001 and ****, P ≤ 0.0001.</a:t>
            </a:r>
            <a:endParaRPr lang="zh-CN" altLang="zh-CN" sz="12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CF098EB-5E4A-6E0A-7A9E-55C2939AD7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9150" y="554403"/>
            <a:ext cx="5219700" cy="1765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24002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553902F0-6289-B2A2-EC8B-7F347EBA3E0A}"/>
              </a:ext>
            </a:extLst>
          </p:cNvPr>
          <p:cNvSpPr txBox="1"/>
          <p:nvPr/>
        </p:nvSpPr>
        <p:spPr>
          <a:xfrm>
            <a:off x="416378" y="2464707"/>
            <a:ext cx="6025243" cy="17250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. S5 Genetically blocking JA biosynthesis in scion decreases cold tolerance.</a:t>
            </a:r>
            <a:endParaRPr lang="zh-CN" altLang="zh-CN" sz="12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Relative water content (RWC). </a:t>
            </a:r>
            <a:r>
              <a:rPr lang="en-US" altLang="zh-CN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MDA content. Data are the means of three biological replicates (±SDs) with three technical replicates each. Seedlings of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pr8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and CM (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astlemart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grafted onto </a:t>
            </a:r>
            <a:r>
              <a:rPr lang="en-US" altLang="zh-CN" sz="1200" kern="100" dirty="0" err="1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hab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rootstock, and of 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pr8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homo-grafted (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pr8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/</a:t>
            </a:r>
            <a:r>
              <a:rPr lang="en-US" altLang="zh-CN" sz="1200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pr8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were treated with cold at 4 °C for 48 h, respectively. Statistical significance levels (Student’s t-test) are shown: ns, no significant; *, P ≤ 0.05; **, P ≤ 0.01; ***, P ≤ 0.001 and ****, P ≤ 0.0001.</a:t>
            </a:r>
            <a:endParaRPr lang="zh-CN" altLang="zh-CN" sz="12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E9AAED68-C6B1-E4A4-66F8-5CE6BBD331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6378" y="294203"/>
            <a:ext cx="6261100" cy="2197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4489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574</Words>
  <Application>Microsoft Macintosh PowerPoint</Application>
  <PresentationFormat>A4 纸张(210x297 毫米)</PresentationFormat>
  <Paragraphs>10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DengXian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User</dc:creator>
  <cp:lastModifiedBy>Microsoft Office User</cp:lastModifiedBy>
  <cp:revision>3</cp:revision>
  <dcterms:created xsi:type="dcterms:W3CDTF">2022-09-23T07:31:48Z</dcterms:created>
  <dcterms:modified xsi:type="dcterms:W3CDTF">2022-09-23T09:45:01Z</dcterms:modified>
</cp:coreProperties>
</file>